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</p:sldIdLst>
  <p:sldSz cx="9144000" cy="6858000"/>
  <p:notesSz cx="9928225" cy="67960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0" y="0"/>
            <a:ext cx="9928800" cy="6796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4303800" cy="33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dt" idx="7"/>
          </p:nvPr>
        </p:nvSpPr>
        <p:spPr>
          <a:xfrm>
            <a:off x="5624640" y="0"/>
            <a:ext cx="4303440" cy="33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 type="sldImg"/>
          </p:nvPr>
        </p:nvSpPr>
        <p:spPr>
          <a:xfrm>
            <a:off x="3265200" y="509760"/>
            <a:ext cx="340020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body"/>
          </p:nvPr>
        </p:nvSpPr>
        <p:spPr>
          <a:xfrm>
            <a:off x="991800" y="3228840"/>
            <a:ext cx="7945560" cy="305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 type="ftr" idx="8"/>
          </p:nvPr>
        </p:nvSpPr>
        <p:spPr>
          <a:xfrm>
            <a:off x="-360" y="6456240"/>
            <a:ext cx="4303800" cy="33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 type="sldNum" idx="9"/>
          </p:nvPr>
        </p:nvSpPr>
        <p:spPr>
          <a:xfrm>
            <a:off x="5624640" y="6456240"/>
            <a:ext cx="4303440" cy="33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051E2D-7422-4F3D-B565-6C96C2FA20E2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sldImg"/>
          </p:nvPr>
        </p:nvSpPr>
        <p:spPr>
          <a:xfrm>
            <a:off x="3265560" y="509760"/>
            <a:ext cx="3400200" cy="2549520"/>
          </a:xfrm>
          <a:prstGeom prst="rect">
            <a:avLst/>
          </a:prstGeom>
          <a:ln w="0">
            <a:noFill/>
          </a:ln>
        </p:spPr>
      </p:sp>
      <p:sp>
        <p:nvSpPr>
          <p:cNvPr id="118" name="PlaceHolder 2"/>
          <p:cNvSpPr>
            <a:spLocks noGrp="1"/>
          </p:cNvSpPr>
          <p:nvPr>
            <p:ph type="body"/>
          </p:nvPr>
        </p:nvSpPr>
        <p:spPr>
          <a:xfrm>
            <a:off x="991800" y="3228840"/>
            <a:ext cx="7945560" cy="3059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Arial"/>
              <a:ea typeface="宋体"/>
            </a:endParaRPr>
          </a:p>
        </p:txBody>
      </p:sp>
      <p:sp>
        <p:nvSpPr>
          <p:cNvPr id="119" name="灯片编号占位符 3"/>
          <p:cNvSpPr/>
          <p:nvPr/>
        </p:nvSpPr>
        <p:spPr>
          <a:xfrm>
            <a:off x="5624640" y="6456240"/>
            <a:ext cx="430344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4765F4-E77E-4861-BE50-85EA808C9A4C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sldImg"/>
          </p:nvPr>
        </p:nvSpPr>
        <p:spPr>
          <a:xfrm>
            <a:off x="3265560" y="509760"/>
            <a:ext cx="3400200" cy="2549520"/>
          </a:xfrm>
          <a:prstGeom prst="rect">
            <a:avLst/>
          </a:prstGeom>
          <a:ln w="0">
            <a:noFill/>
          </a:ln>
        </p:spPr>
      </p:sp>
      <p:sp>
        <p:nvSpPr>
          <p:cNvPr id="121" name="PlaceHolder 2"/>
          <p:cNvSpPr>
            <a:spLocks noGrp="1"/>
          </p:cNvSpPr>
          <p:nvPr>
            <p:ph type="body"/>
          </p:nvPr>
        </p:nvSpPr>
        <p:spPr>
          <a:xfrm>
            <a:off x="991800" y="3228840"/>
            <a:ext cx="7945560" cy="3059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Arial"/>
              <a:ea typeface="宋体"/>
            </a:endParaRPr>
          </a:p>
        </p:txBody>
      </p:sp>
      <p:sp>
        <p:nvSpPr>
          <p:cNvPr id="122" name="灯片编号占位符 3"/>
          <p:cNvSpPr/>
          <p:nvPr/>
        </p:nvSpPr>
        <p:spPr>
          <a:xfrm>
            <a:off x="5624640" y="6456240"/>
            <a:ext cx="430344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222504-048F-40D2-8CD9-B56E34B68A49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3265560" y="509760"/>
            <a:ext cx="3400200" cy="254952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991800" y="3228840"/>
            <a:ext cx="7945560" cy="3059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Arial"/>
              <a:ea typeface="宋体"/>
            </a:endParaRPr>
          </a:p>
        </p:txBody>
      </p:sp>
      <p:sp>
        <p:nvSpPr>
          <p:cNvPr id="125" name="灯片编号占位符 3"/>
          <p:cNvSpPr/>
          <p:nvPr/>
        </p:nvSpPr>
        <p:spPr>
          <a:xfrm>
            <a:off x="5624640" y="6456240"/>
            <a:ext cx="430344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08DDFD-6107-43E9-9448-3C4CE7CE741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sldImg"/>
          </p:nvPr>
        </p:nvSpPr>
        <p:spPr>
          <a:xfrm>
            <a:off x="3265560" y="509760"/>
            <a:ext cx="3400200" cy="2549520"/>
          </a:xfrm>
          <a:prstGeom prst="rect">
            <a:avLst/>
          </a:prstGeom>
          <a:ln w="0">
            <a:noFill/>
          </a:ln>
        </p:spPr>
      </p:sp>
      <p:sp>
        <p:nvSpPr>
          <p:cNvPr id="127" name="PlaceHolder 2"/>
          <p:cNvSpPr>
            <a:spLocks noGrp="1"/>
          </p:cNvSpPr>
          <p:nvPr>
            <p:ph type="body"/>
          </p:nvPr>
        </p:nvSpPr>
        <p:spPr>
          <a:xfrm>
            <a:off x="991800" y="3228840"/>
            <a:ext cx="7945560" cy="3059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Arial"/>
              <a:ea typeface="宋体"/>
            </a:endParaRPr>
          </a:p>
        </p:txBody>
      </p:sp>
      <p:sp>
        <p:nvSpPr>
          <p:cNvPr id="128" name="灯片编号占位符 3"/>
          <p:cNvSpPr/>
          <p:nvPr/>
        </p:nvSpPr>
        <p:spPr>
          <a:xfrm>
            <a:off x="5624640" y="6456240"/>
            <a:ext cx="430344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A4B4A3-4BB5-4B61-9830-38ABD2491BEB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D4737-D009-4C8C-A940-902F943F49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020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F25A0-F884-44CA-83CC-57C394F310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020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020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F8B28-6CC4-4F21-8FE7-5F4D985EE7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7524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7524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020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020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020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281C9-7E0B-4807-ABF7-8F8EBF0030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6893514-A65C-4685-8455-BC4B0DD33D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7524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439708C-7480-4823-B9EE-9163A034C9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57CE441-281D-4E2F-93DB-6FC1C6ABC9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DEAE7FF-8078-4B7A-9185-3BCE98AA12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EA1D4B9-0871-4896-9BE9-7A5B310DFE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51F783E-E8F3-4F3C-8AFE-58B636B4A5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020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3C7BF76-8D1C-489B-9F23-7AA54FAAA4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7524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3FD61-D793-4E37-8BEF-C2D34AE0DD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020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59B1F2A-CF2C-4FA4-8E29-90DE39A3A8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020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FFEBE95-9C41-4B91-A55E-DF089C0BC6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020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F95389B-3B38-4CF9-A17F-425595DAA9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020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020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7FDCA98-70E2-426B-AADB-49F08EA8CD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7524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7524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020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020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020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AA7B652-99CF-432C-BD6B-C233DB6935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60B25-D286-4FB8-AE1B-D7F79A47DB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C709A-AB87-450D-A0B8-A1C4EA8F98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FE6A6-B266-453B-9E9F-3E3C85749B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6791BE-AB03-48A8-9F87-4360AD9167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020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01804-BF37-4D42-9483-8C348D4996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020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EEF990-B98E-42EC-BAE7-EF4D748041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7524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020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B069C-0849-4A53-A90A-8FAAD5CEAC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7524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3CF1C2-5BD3-4E1E-AEE0-C2660E589581}" type="slidenum">
              <a:rPr b="1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zh-CN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zh-CN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80B836-9576-4371-BA06-136497FC11CE}" type="slidenum">
              <a:rPr b="1" lang="zh-CN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3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4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5.wmf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9" name="对象 6"/>
          <p:cNvGraphicFramePr/>
          <p:nvPr/>
        </p:nvGraphicFramePr>
        <p:xfrm>
          <a:off x="1181160" y="1773360"/>
          <a:ext cx="3562200" cy="2501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0" name="对象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81160" y="1773360"/>
                    <a:ext cx="3562200" cy="2501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657000" y="958680"/>
            <a:ext cx="704844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 Gene expression profiling of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SUS3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life cycle of ric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9"/>
          <p:cNvSpPr/>
          <p:nvPr/>
        </p:nvSpPr>
        <p:spPr>
          <a:xfrm>
            <a:off x="752400" y="4433760"/>
            <a:ext cx="75646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X-axis indicates the 33 developmental tissues with 1-5, calli;  6, seed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mbibition; 7, seed germination; 8-11, plumule/radicle under dark/light; 12, seedlings; 13, young shoot; 14, young root; 15-16, mature/old leaf; 17-18, mature/old sheath; 19-20, young/old flag leaf; 21-25, panicle at 5 developmental stage; 26-27, young/old stem; 28, hull; 29, spikelet; 30, stamen; 31-33, endosperm of  7/14/21 DAP (days after pollination)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Y-axis presents the expression values obtained from the microarray analysis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标题 23"/>
          <p:cNvSpPr/>
          <p:nvPr/>
        </p:nvSpPr>
        <p:spPr>
          <a:xfrm>
            <a:off x="420840" y="622440"/>
            <a:ext cx="8413560" cy="35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Fig. S2 Biomass enzymatic saccharification and ethanol production of the </a:t>
            </a:r>
            <a:r>
              <a:rPr b="1" i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OsSUS3</a:t>
            </a: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-transgenic rice plants. (a) Hexose yields released from enzymatic hydrolysis after the pretreatment with 1% NaOH or 1% H</a:t>
            </a:r>
            <a:r>
              <a:rPr b="1" lang="en-US" sz="1200" spc="-1" strike="noStrike" baseline="-25000">
                <a:solidFill>
                  <a:srgbClr val="ff0000"/>
                </a:solidFill>
                <a:latin typeface="Times New Roman"/>
                <a:ea typeface="Times New Roman"/>
              </a:rPr>
              <a:t>2</a:t>
            </a: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O</a:t>
            </a:r>
            <a:r>
              <a:rPr b="1" lang="en-US" sz="1200" spc="-1" strike="noStrike" baseline="-25000">
                <a:solidFill>
                  <a:srgbClr val="ff0000"/>
                </a:solidFill>
                <a:latin typeface="Times New Roman"/>
                <a:ea typeface="Times New Roman"/>
              </a:rPr>
              <a:t>4</a:t>
            </a: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. (b) Bioethanol yields obtained from yeast fermentation using the sugars released from biomass enzymatic hydrolysis as performed in (a).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81"/>
          <p:cNvSpPr/>
          <p:nvPr/>
        </p:nvSpPr>
        <p:spPr>
          <a:xfrm>
            <a:off x="1581480" y="121752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81"/>
          <p:cNvSpPr/>
          <p:nvPr/>
        </p:nvSpPr>
        <p:spPr>
          <a:xfrm>
            <a:off x="1556280" y="3691080"/>
            <a:ext cx="1242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6" name="对象 17"/>
          <p:cNvGraphicFramePr/>
          <p:nvPr/>
        </p:nvGraphicFramePr>
        <p:xfrm>
          <a:off x="4383000" y="1371600"/>
          <a:ext cx="2249640" cy="2160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7" name="对象 1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383000" y="1371600"/>
                    <a:ext cx="2249640" cy="2160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8" name="对象 18"/>
          <p:cNvGraphicFramePr/>
          <p:nvPr/>
        </p:nvGraphicFramePr>
        <p:xfrm>
          <a:off x="1760400" y="1366920"/>
          <a:ext cx="2249640" cy="21603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99" name="对象 1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760400" y="1366920"/>
                    <a:ext cx="2249640" cy="21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0" name="对象 1"/>
          <p:cNvGraphicFramePr/>
          <p:nvPr/>
        </p:nvGraphicFramePr>
        <p:xfrm>
          <a:off x="1757520" y="3753000"/>
          <a:ext cx="2247840" cy="21603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01" name="对象 1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757520" y="3753000"/>
                    <a:ext cx="2247840" cy="21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2" name="对象 2"/>
          <p:cNvGraphicFramePr/>
          <p:nvPr/>
        </p:nvGraphicFramePr>
        <p:xfrm>
          <a:off x="4381560" y="3753000"/>
          <a:ext cx="2251080" cy="21603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03" name="对象 2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381560" y="3753000"/>
                    <a:ext cx="2251080" cy="21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4" name="矩形 1"/>
          <p:cNvSpPr/>
          <p:nvPr/>
        </p:nvSpPr>
        <p:spPr>
          <a:xfrm>
            <a:off x="420840" y="6040440"/>
            <a:ext cx="841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l data are given as means ± SD. A Student’s 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est was performed between transgenic plants and ZH11 as **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1 and *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5 (n = 3)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5" name=""/>
          <p:cNvGraphicFramePr/>
          <p:nvPr/>
        </p:nvGraphicFramePr>
        <p:xfrm>
          <a:off x="1085760" y="1492200"/>
          <a:ext cx="5532480" cy="1895400"/>
        </p:xfrm>
        <a:graphic>
          <a:graphicData uri="http://schemas.openxmlformats.org/drawingml/2006/table">
            <a:tbl>
              <a:tblPr/>
              <a:tblGrid>
                <a:gridCol w="595440"/>
                <a:gridCol w="744480"/>
                <a:gridCol w="1041480"/>
                <a:gridCol w="990720"/>
                <a:gridCol w="196560"/>
                <a:gridCol w="960480"/>
                <a:gridCol w="1003320"/>
              </a:tblGrid>
              <a:tr h="260280">
                <a:tc gridSpan="2" rowSpan="2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ansgeni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ne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iomass  production (g/plant)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ed yield (g/plant)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492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1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15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1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15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0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H1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.81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96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73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29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1±1.69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92±1.15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ecto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V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.63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2.1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9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6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.56±2.2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9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65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1520">
                <a:tc rowSpan="3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CesA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::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S3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67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75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5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11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.19±3.9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1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8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.30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11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8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01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.20±3.5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6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9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1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50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73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28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99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.36±2.8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50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39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448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.5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35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55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25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.54±1.9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90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0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1197000" y="1006560"/>
            <a:ext cx="5376960" cy="3556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Table S1.  Biomass and seed yields in two-year field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矩形 4"/>
          <p:cNvSpPr/>
          <p:nvPr/>
        </p:nvSpPr>
        <p:spPr>
          <a:xfrm>
            <a:off x="733320" y="3592440"/>
            <a:ext cx="6300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**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dicated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ignificant difference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etween transgenic lines and ZH11 control 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y </a:t>
            </a:r>
            <a:r>
              <a:rPr b="0" i="1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est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s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 0.05 and 0.01 (n=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标题 2"/>
          <p:cNvSpPr/>
          <p:nvPr/>
        </p:nvSpPr>
        <p:spPr>
          <a:xfrm>
            <a:off x="309600" y="423720"/>
            <a:ext cx="82296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9" name=""/>
          <p:cNvGraphicFramePr/>
          <p:nvPr/>
        </p:nvGraphicFramePr>
        <p:xfrm>
          <a:off x="1104840" y="1876320"/>
          <a:ext cx="6353280" cy="1987560"/>
        </p:xfrm>
        <a:graphic>
          <a:graphicData uri="http://schemas.openxmlformats.org/drawingml/2006/table">
            <a:tbl>
              <a:tblPr/>
              <a:tblGrid>
                <a:gridCol w="711360"/>
                <a:gridCol w="487440"/>
                <a:gridCol w="903240"/>
                <a:gridCol w="568080"/>
                <a:gridCol w="903240"/>
                <a:gridCol w="587520"/>
                <a:gridCol w="965160"/>
                <a:gridCol w="865080"/>
                <a:gridCol w="362160"/>
              </a:tblGrid>
              <a:tr h="44604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ulose conten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%dry matter)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micellulose  conten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%dry matter) 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gnin conten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%dry matter) 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I 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%)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2248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H1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H1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.35±0.1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34±0.10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.85±0.17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.55±0.6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ecto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K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.62±0.4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56±0.10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.79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95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1.51±0.66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3280">
                <a:tc rowSpan="4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CesA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::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S3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15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15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3%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@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.74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19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5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.90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97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.6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35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7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1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45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1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9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89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1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9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.42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6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.30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58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7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1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13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29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7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.79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07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21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.26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1.16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.40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64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0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1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14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24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4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.80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07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21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.84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5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.74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0.53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9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1298160" y="1361880"/>
            <a:ext cx="6421320" cy="407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. Three major wall polymer levels and CrI values in the mature stem tissu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矩形 3"/>
          <p:cNvSpPr/>
          <p:nvPr/>
        </p:nvSpPr>
        <p:spPr>
          <a:xfrm>
            <a:off x="749160" y="4568760"/>
            <a:ext cx="7078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**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dicated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ignificant difference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etween transgenic lines and ZH11 control 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y </a:t>
            </a:r>
            <a:r>
              <a:rPr b="0" i="1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est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s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 0.05 and 0.01 (n=3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;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@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rcentage of increased or decreased level between transgenic line and ZH11 by subtraction of two values divided by ZH11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1012680" y="1162080"/>
            <a:ext cx="7283520" cy="3333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3. Sucrose, fructose and glucose contents of OsSUS3-transgenic rice plants in mature stem.</a:t>
            </a: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3" name=""/>
          <p:cNvGraphicFramePr/>
          <p:nvPr/>
        </p:nvGraphicFramePr>
        <p:xfrm>
          <a:off x="1104840" y="1604880"/>
          <a:ext cx="5896080" cy="1947960"/>
        </p:xfrm>
        <a:graphic>
          <a:graphicData uri="http://schemas.openxmlformats.org/drawingml/2006/table">
            <a:tbl>
              <a:tblPr/>
              <a:tblGrid>
                <a:gridCol w="771480"/>
                <a:gridCol w="647640"/>
                <a:gridCol w="1067040"/>
                <a:gridCol w="609480"/>
                <a:gridCol w="933480"/>
                <a:gridCol w="581040"/>
                <a:gridCol w="942840"/>
                <a:gridCol w="343080"/>
              </a:tblGrid>
              <a:tr h="471600">
                <a:tc gridSpan="2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ansgenic line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crose (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µ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/g FW)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uctose (µ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/g FW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)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ucose (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µ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/g FW)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523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H1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H1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19.47±55.4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.19±0.76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.70±1.19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484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ecto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V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41.28±28.9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4.56±0.2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.92±0.36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4840">
                <a:tc rowSpan="4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CesA8::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S3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1.47±19.44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4%†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4.98±1.3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.51±1.11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0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2.13±7.40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62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.70±0.90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2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10±0.42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61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4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0.93±10.51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60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3.84±0.12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8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.61±0.95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8%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9.61±7.28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5%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.87±0.77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6%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83±0.48**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9%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14" name="矩形 5"/>
          <p:cNvSpPr/>
          <p:nvPr/>
        </p:nvSpPr>
        <p:spPr>
          <a:xfrm>
            <a:off x="1017720" y="3975120"/>
            <a:ext cx="72784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W: fresh weight;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dicated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ignificant difference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etween transgenic line and ZH11 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y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udent’s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i="1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est at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 0.05 and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 0.0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;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†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rcentage of increased or decreased level between transgenic plants and ZH11 by subtraction of two values divided by value of ZH11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5" name=""/>
          <p:cNvGraphicFramePr/>
          <p:nvPr/>
        </p:nvGraphicFramePr>
        <p:xfrm>
          <a:off x="657360" y="1447920"/>
          <a:ext cx="8115120" cy="3308400"/>
        </p:xfrm>
        <a:graphic>
          <a:graphicData uri="http://schemas.openxmlformats.org/drawingml/2006/table">
            <a:tbl>
              <a:tblPr/>
              <a:tblGrid>
                <a:gridCol w="799920"/>
                <a:gridCol w="1000080"/>
                <a:gridCol w="3133800"/>
                <a:gridCol w="3181320"/>
              </a:tblGrid>
              <a:tr h="26964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urpose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rward primers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verse primers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CesA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moter  clone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CAAGCTTCAGAGGAAACTCAGATGTGATG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GCGTCGACCTTCGAATTCCCCTGTTTGGAG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34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SUS3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 clone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CCCCGGGATGGGGGAAACTACTGGAG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CCCCGGGCATTGCCCATTCTTTTCA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SUS3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GAGACACGCCGCTACCTGGAG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CTGAAATCAACTAAACCC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4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SA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CATGGTGGCGGGTATA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GCGACGGCTTTCTGAG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SA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GTAGATAGAAACACGAAAGGTG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ATGGGCACCCACACACG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4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SA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ATCGTCTACCCGTTCAC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CAGCCCAGCAATCATCT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SA7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TAACGGGGTTCAAGATG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GGTGTTGGTGTAGGCG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SA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GTCGGTGTTGTTGCTGG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GGTCGGAGTGCGGTTT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4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SA9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CAAGAACGGCAACCTC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GAACAAACTCGCAAACG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9B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TCCTCTACAAAACCCCAA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AATCCACTCGCTGAACCAT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16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9B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CGATCTCCTCTACGACTG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CCGTTCCTGCCATT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4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9B16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AACCACCAAGTAGCCAT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ATACACGACAAAGTCAACGAA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RX9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AAGGAGATGATGATTTTAGCA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GCGGAGGTCGTAGATGTCG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692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RX1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TGGATGGTGTGATTGTG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TGAACTGGAAGAGGCAT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4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BQ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-PCR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AGGACAAGATGATCTGC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GAAGCTGAAGCATCCAG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16" name="Rectangle 148"/>
          <p:cNvSpPr/>
          <p:nvPr/>
        </p:nvSpPr>
        <p:spPr>
          <a:xfrm>
            <a:off x="668160" y="960480"/>
            <a:ext cx="3039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4. Primers used for Q-PCR analysis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4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1T05:43:24Z</dcterms:created>
  <dc:creator>Administrator</dc:creator>
  <dc:description/>
  <dc:language>en-US</dc:language>
  <cp:lastModifiedBy>AutoBVT</cp:lastModifiedBy>
  <cp:lastPrinted>2016-11-23T01:58:26Z</cp:lastPrinted>
  <dcterms:modified xsi:type="dcterms:W3CDTF">2017-08-14T01:59:43Z</dcterms:modified>
  <cp:revision>230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998</vt:lpwstr>
  </property>
  <property fmtid="{D5CDD505-2E9C-101B-9397-08002B2CF9AE}" pid="3" name="Version">
    <vt:r8>7</vt:r8>
  </property>
</Properties>
</file>